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 showGuides="1">
      <p:cViewPr varScale="1">
        <p:scale>
          <a:sx n="79" d="100"/>
          <a:sy n="79" d="100"/>
        </p:scale>
        <p:origin x="3064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964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354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005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135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829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06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739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283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69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392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885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19144-0D18-C04A-9611-ABF1EFD76E8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4AEB6-788F-CC46-ABEF-D4122A6FB3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62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>
            <a:extLst>
              <a:ext uri="{FF2B5EF4-FFF2-40B4-BE49-F238E27FC236}">
                <a16:creationId xmlns:a16="http://schemas.microsoft.com/office/drawing/2014/main" id="{14D4E822-2341-1446-BDBD-F7105C9E36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312" y="2530515"/>
            <a:ext cx="58594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le 2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: Assembly of </a:t>
            </a:r>
            <a:r>
              <a:rPr lang="en-US" altLang="en-US" sz="10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b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-telomeres and filling up N-gaps in the genome assembly of </a:t>
            </a:r>
            <a:r>
              <a:rPr kumimoji="0" lang="en-US" altLang="en-US" sz="100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. tropicalis 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using</a:t>
            </a:r>
            <a:r>
              <a:rPr kumimoji="0" lang="en-US" altLang="en-US" sz="100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de novo 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ssembled contigs.</a:t>
            </a:r>
            <a:endParaRPr kumimoji="0" lang="en-US" altLang="en-US" sz="100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7E016DB3-5BDB-2F4A-89F6-C19462C44A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0525679"/>
              </p:ext>
            </p:extLst>
          </p:nvPr>
        </p:nvGraphicFramePr>
        <p:xfrm>
          <a:off x="206312" y="3045456"/>
          <a:ext cx="6445375" cy="190754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21344">
                  <a:extLst>
                    <a:ext uri="{9D8B030D-6E8A-4147-A177-3AD203B41FA5}">
                      <a16:colId xmlns:a16="http://schemas.microsoft.com/office/drawing/2014/main" val="1401978516"/>
                    </a:ext>
                  </a:extLst>
                </a:gridCol>
                <a:gridCol w="842850">
                  <a:extLst>
                    <a:ext uri="{9D8B030D-6E8A-4147-A177-3AD203B41FA5}">
                      <a16:colId xmlns:a16="http://schemas.microsoft.com/office/drawing/2014/main" val="2256065629"/>
                    </a:ext>
                  </a:extLst>
                </a:gridCol>
                <a:gridCol w="842850">
                  <a:extLst>
                    <a:ext uri="{9D8B030D-6E8A-4147-A177-3AD203B41FA5}">
                      <a16:colId xmlns:a16="http://schemas.microsoft.com/office/drawing/2014/main" val="4062450363"/>
                    </a:ext>
                  </a:extLst>
                </a:gridCol>
                <a:gridCol w="1179990">
                  <a:extLst>
                    <a:ext uri="{9D8B030D-6E8A-4147-A177-3AD203B41FA5}">
                      <a16:colId xmlns:a16="http://schemas.microsoft.com/office/drawing/2014/main" val="3725779895"/>
                    </a:ext>
                  </a:extLst>
                </a:gridCol>
                <a:gridCol w="1621620">
                  <a:extLst>
                    <a:ext uri="{9D8B030D-6E8A-4147-A177-3AD203B41FA5}">
                      <a16:colId xmlns:a16="http://schemas.microsoft.com/office/drawing/2014/main" val="2030245647"/>
                    </a:ext>
                  </a:extLst>
                </a:gridCol>
                <a:gridCol w="1336721">
                  <a:extLst>
                    <a:ext uri="{9D8B030D-6E8A-4147-A177-3AD203B41FA5}">
                      <a16:colId xmlns:a16="http://schemas.microsoft.com/office/drawing/2014/main" val="272397074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en-US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</a:t>
                      </a:r>
                      <a:r>
                        <a:rPr lang="en-IN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l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10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</a:t>
                      </a:r>
                      <a:r>
                        <a:rPr lang="en-IN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l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-gaps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lled N-gap using strategy-I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lled N-gaps  using strategy-II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58563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62693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2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10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7200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36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43496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38 5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</a:t>
                      </a:r>
                      <a:r>
                        <a:rPr lang="en-IN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84802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5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1909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4586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110 5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</a:t>
                      </a:r>
                      <a:r>
                        <a:rPr lang="en-IN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110 3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</a:t>
                      </a:r>
                      <a:r>
                        <a:rPr lang="en-IN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3548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5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4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24768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36428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9506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6</Words>
  <Application>Microsoft Macintosh PowerPoint</Application>
  <PresentationFormat>A4 Paper (210x297 mm)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0:59:54Z</dcterms:created>
  <dcterms:modified xsi:type="dcterms:W3CDTF">2020-05-27T11:01:14Z</dcterms:modified>
</cp:coreProperties>
</file>